
<file path=[Content_Types].xml><?xml version="1.0" encoding="utf-8"?>
<Types xmlns="http://schemas.openxmlformats.org/package/2006/content-types">
  <Default Extension="emf" ContentType="image/x-emf"/>
  <Override PartName="/docProps/core.xml" ContentType="application/vnd.openxmlformats-package.core-properties+xml"/>
  <Override PartName="/ppt/slideLayouts/slideLayout6.xml" ContentType="application/vnd.openxmlformats-officedocument.presentationml.slideLayout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a="http://schemas.openxmlformats.org/drawingml/2006/main" xmlns:r="http://schemas.openxmlformats.org/officeDocument/2006/relationships" xmlns:p="http://schemas.openxmlformats.org/presentationml/2006/main" xmlns:p15="http://schemas.microsoft.com/office/powerpoint/2012/main" xmlns:mv="urn:schemas-microsoft-com:mac:vml" xmlns:mc="http://schemas.openxmlformats.org/markup-compatibility/2006">
        <p15:guide id="3" orient="horz" pos="521" userDrawn="1">
          <p15:clr>
            <a:srgbClr val="A4A3A4"/>
          </p15:clr>
        </p15:guide>
        <p15:guide id="4" pos="32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2767"/>
    </p:ext>
    <p:ext uri="{FD5EFAAD-0ECE-453E-9831-46B23BE46B34}">
      <p15:chartTrackingRefBased xmlns="" xmlns:a="http://schemas.openxmlformats.org/drawingml/2006/main" xmlns:r="http://schemas.openxmlformats.org/officeDocument/2006/relationships" xmlns:p="http://schemas.openxmlformats.org/presentationml/2006/main" xmlns:p15="http://schemas.microsoft.com/office/powerpoint/2012/main" xmlns:mv="urn:schemas-microsoft-com:mac:vml" xmlns:mc="http://schemas.openxmlformats.org/markup-compatibility/2006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SorterView">
  <p:normalViewPr horzBarState="maximized">
    <p:restoredLeft sz="19251"/>
    <p:restoredTop sz="94674"/>
  </p:normalViewPr>
  <p:slideViewPr>
    <p:cSldViewPr snapToGrid="0" snapToObjects="1" showGuides="1">
      <p:cViewPr>
        <p:scale>
          <a:sx n="50" d="100"/>
          <a:sy n="50" d="100"/>
        </p:scale>
        <p:origin x="-2128" y="-376"/>
      </p:cViewPr>
      <p:guideLst>
        <p:guide orient="horz" pos="521"/>
        <p:guide pos="32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820970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946437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6133842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429480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7750442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524415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199161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567086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502618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4789972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144450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5569191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ouper 43"/>
          <p:cNvGrpSpPr/>
          <p:nvPr/>
        </p:nvGrpSpPr>
        <p:grpSpPr>
          <a:xfrm>
            <a:off x="297497" y="537883"/>
            <a:ext cx="6445606" cy="8188398"/>
            <a:chOff x="297497" y="537883"/>
            <a:chExt cx="6445606" cy="8188398"/>
          </a:xfrm>
        </p:grpSpPr>
        <p:grpSp>
          <p:nvGrpSpPr>
            <p:cNvPr id="22" name="Groupe 21">
              <a:extLst>
                <a:ext uri="{FF2B5EF4-FFF2-40B4-BE49-F238E27FC236}">
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5024F17-9249-9541-A92C-0B0C4C6CE1AB}"/>
                </a:ext>
              </a:extLst>
            </p:cNvPr>
            <p:cNvGrpSpPr/>
            <p:nvPr/>
          </p:nvGrpSpPr>
          <p:grpSpPr>
            <a:xfrm>
              <a:off x="377014" y="537883"/>
              <a:ext cx="6366089" cy="7744853"/>
              <a:chOff x="377014" y="537883"/>
              <a:chExt cx="6366089" cy="7744853"/>
            </a:xfrm>
          </p:grpSpPr>
          <p:grpSp>
            <p:nvGrpSpPr>
              <p:cNvPr id="21" name="Groupe 20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6491193-456B-3D4D-BD5A-2FEAD8DF9EB1}"/>
                  </a:ext>
                </a:extLst>
              </p:cNvPr>
              <p:cNvGrpSpPr/>
              <p:nvPr/>
            </p:nvGrpSpPr>
            <p:grpSpPr>
              <a:xfrm>
                <a:off x="377014" y="4385227"/>
                <a:ext cx="6366089" cy="3897509"/>
                <a:chOff x="377014" y="4385227"/>
                <a:chExt cx="6366089" cy="3897509"/>
              </a:xfrm>
            </p:grpSpPr>
            <p:sp>
              <p:nvSpPr>
                <p:cNvPr id="182" name="ZoneTexte 181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42AC261-74BF-1142-8560-4631B1D61B3F}"/>
                    </a:ext>
                  </a:extLst>
                </p:cNvPr>
                <p:cNvSpPr txBox="1"/>
                <p:nvPr/>
              </p:nvSpPr>
              <p:spPr>
                <a:xfrm>
                  <a:off x="377014" y="4385227"/>
                  <a:ext cx="32412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b="1" dirty="0"/>
                    <a:t>B</a:t>
                  </a:r>
                </a:p>
              </p:txBody>
            </p:sp>
            <p:grpSp>
              <p:nvGrpSpPr>
                <p:cNvPr id="20" name="Groupe 19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3E63D78-17DD-494A-96E5-EFB1D2A58FD7}"/>
                    </a:ext>
                  </a:extLst>
                </p:cNvPr>
                <p:cNvGrpSpPr/>
                <p:nvPr/>
              </p:nvGrpSpPr>
              <p:grpSpPr>
                <a:xfrm>
                  <a:off x="843319" y="4581559"/>
                  <a:ext cx="5899784" cy="3701177"/>
                  <a:chOff x="843319" y="4581559"/>
                  <a:chExt cx="5899784" cy="3701177"/>
                </a:xfrm>
              </p:grpSpPr>
              <p:pic>
                <p:nvPicPr>
                  <p:cNvPr id="5" name="Image 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7555688-C9F7-E64E-B3EB-E00D4CC6C9AB}"/>
                      </a:ext>
                    </a:extLst>
                  </p:cNvPr>
                  <p:cNvPicPr>
                    <a:picLocks/>
                  </p:cNvPicPr>
                  <p:nvPr/>
                </p:nvPicPr>
                <p:blipFill>
                  <a:blip r:embed="rId2"/>
                  <a:stretch>
                    <a:fillRect/>
                  </a:stretch>
                </p:blipFill>
                <p:spPr>
                  <a:xfrm>
                    <a:off x="1355330" y="4581559"/>
                    <a:ext cx="4171411" cy="2880000"/>
                  </a:xfrm>
                  <a:prstGeom prst="rect">
                    <a:avLst/>
                  </a:prstGeom>
                </p:spPr>
              </p:pic>
              <p:sp>
                <p:nvSpPr>
                  <p:cNvPr id="174" name="ZoneTexte 17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41B79EE-2536-EC41-9F5C-ABECF4EA0D13}"/>
                      </a:ext>
                    </a:extLst>
                  </p:cNvPr>
                  <p:cNvSpPr txBox="1"/>
                  <p:nvPr/>
                </p:nvSpPr>
                <p:spPr>
                  <a:xfrm>
                    <a:off x="5388246" y="7461559"/>
                    <a:ext cx="135485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400" b="1" dirty="0">
                        <a:latin typeface="Arial"/>
                        <a:cs typeface="Arial"/>
                      </a:rPr>
                      <a:t>10 </a:t>
                    </a:r>
                    <a:r>
                      <a:rPr lang="fr-FR" sz="1400" b="1" dirty="0" err="1">
                        <a:latin typeface="Arial"/>
                        <a:cs typeface="Arial"/>
                      </a:rPr>
                      <a:t>μM</a:t>
                    </a:r>
                    <a:r>
                      <a:rPr lang="fr-FR" sz="1400" b="1" dirty="0">
                        <a:latin typeface="Arial"/>
                        <a:cs typeface="Arial"/>
                      </a:rPr>
                      <a:t> H</a:t>
                    </a:r>
                    <a:r>
                      <a:rPr lang="fr-FR" sz="1400" b="1" baseline="-25000" dirty="0">
                        <a:latin typeface="Arial"/>
                        <a:cs typeface="Arial"/>
                      </a:rPr>
                      <a:t>2</a:t>
                    </a:r>
                    <a:r>
                      <a:rPr lang="fr-FR" sz="1400" b="1" dirty="0">
                        <a:latin typeface="Arial"/>
                        <a:cs typeface="Arial"/>
                      </a:rPr>
                      <a:t>O</a:t>
                    </a:r>
                    <a:r>
                      <a:rPr lang="fr-FR" sz="1400" b="1" baseline="-25000" dirty="0">
                        <a:latin typeface="Arial"/>
                        <a:cs typeface="Arial"/>
                      </a:rPr>
                      <a:t>2</a:t>
                    </a:r>
                  </a:p>
                </p:txBody>
              </p:sp>
              <p:sp>
                <p:nvSpPr>
                  <p:cNvPr id="181" name="ZoneTexte 180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878A021-4EC4-FD4E-AE8C-DD3CCA86A343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-4028" y="5867670"/>
                    <a:ext cx="2002471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fr-FR" sz="1400" b="1" dirty="0">
                        <a:latin typeface="Arial"/>
                        <a:cs typeface="Arial"/>
                      </a:rPr>
                      <a:t>Gene expression </a:t>
                    </a:r>
                    <a:r>
                      <a:rPr lang="fr-FR" sz="1400" b="1" dirty="0" err="1">
                        <a:latin typeface="Arial"/>
                        <a:cs typeface="Arial"/>
                      </a:rPr>
                      <a:t>fold</a:t>
                    </a:r>
                    <a:endParaRPr lang="fr-FR" sz="1400" b="1" dirty="0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18" name="Groupe 1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584845E-46A8-E545-8045-6FA4FE0496C7}"/>
                      </a:ext>
                    </a:extLst>
                  </p:cNvPr>
                  <p:cNvGrpSpPr/>
                  <p:nvPr/>
                </p:nvGrpSpPr>
                <p:grpSpPr>
                  <a:xfrm>
                    <a:off x="1660099" y="7461559"/>
                    <a:ext cx="1698339" cy="821177"/>
                    <a:chOff x="1660099" y="7461559"/>
                    <a:chExt cx="1698339" cy="821177"/>
                  </a:xfrm>
                </p:grpSpPr>
                <p:sp>
                  <p:nvSpPr>
                    <p:cNvPr id="134" name="ZoneTexte 13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A9E70C0-910B-E941-BD41-D17817866A0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86153" y="7759516"/>
                      <a:ext cx="1446230" cy="52322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LIMLP_02790</a:t>
                      </a:r>
                    </a:p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Zinc hydrolase</a:t>
                      </a:r>
                    </a:p>
                  </p:txBody>
                </p:sp>
                <p:grpSp>
                  <p:nvGrpSpPr>
                    <p:cNvPr id="2" name="Groupe 1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69434D6-5D08-1C4D-AC3F-2752C398C6F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817935" y="7461559"/>
                      <a:ext cx="1382666" cy="307777"/>
                      <a:chOff x="1822028" y="7461559"/>
                      <a:chExt cx="1382666" cy="307777"/>
                    </a:xfrm>
                  </p:grpSpPr>
                  <p:sp>
                    <p:nvSpPr>
                      <p:cNvPr id="175" name="ZoneTexte 17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7D4EE26-2CFB-BB4A-A92C-D5A8D8E13D5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822028" y="7461559"/>
                        <a:ext cx="248786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400" b="1" dirty="0">
                            <a:latin typeface="Arial"/>
                            <a:cs typeface="Arial"/>
                          </a:rPr>
                          <a:t>-</a:t>
                        </a:r>
                      </a:p>
                    </p:txBody>
                  </p:sp>
                  <p:sp>
                    <p:nvSpPr>
                      <p:cNvPr id="176" name="ZoneTexte 17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AB15987-F634-164C-9D55-0678CCA52AF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378774" y="7461559"/>
                        <a:ext cx="289512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400" b="1" dirty="0">
                            <a:latin typeface="Arial"/>
                            <a:cs typeface="Arial"/>
                          </a:rPr>
                          <a:t>+</a:t>
                        </a:r>
                      </a:p>
                    </p:txBody>
                  </p:sp>
                  <p:sp>
                    <p:nvSpPr>
                      <p:cNvPr id="177" name="ZoneTexte 176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9007239-19FD-3E40-A3CE-BEF4B7CE809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915182" y="7461559"/>
                        <a:ext cx="289512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400" b="1" dirty="0">
                            <a:latin typeface="Arial"/>
                            <a:cs typeface="Arial"/>
                          </a:rPr>
                          <a:t>+</a:t>
                        </a:r>
                      </a:p>
                    </p:txBody>
                  </p:sp>
                </p:grpSp>
                <p:sp>
                  <p:nvSpPr>
                    <p:cNvPr id="31" name="Parenthèse ouvrante 3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CB5C453-AE29-714F-862E-CC3CF92112C5}"/>
                        </a:ext>
                      </a:extLst>
                    </p:cNvPr>
                    <p:cNvSpPr/>
                    <p:nvPr/>
                  </p:nvSpPr>
                  <p:spPr>
                    <a:xfrm rot="16200000">
                      <a:off x="2444878" y="6830237"/>
                      <a:ext cx="128781" cy="1698339"/>
                    </a:xfrm>
                    <a:prstGeom prst="leftBracket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</p:grpSp>
              <p:grpSp>
                <p:nvGrpSpPr>
                  <p:cNvPr id="19" name="Groupe 18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4BB02EA-26C3-0A42-82D6-2EF09925CE7D}"/>
                      </a:ext>
                    </a:extLst>
                  </p:cNvPr>
                  <p:cNvGrpSpPr/>
                  <p:nvPr/>
                </p:nvGrpSpPr>
                <p:grpSpPr>
                  <a:xfrm>
                    <a:off x="3660529" y="7461559"/>
                    <a:ext cx="1698339" cy="821177"/>
                    <a:chOff x="3660529" y="7461559"/>
                    <a:chExt cx="1698339" cy="821177"/>
                  </a:xfrm>
                </p:grpSpPr>
                <p:sp>
                  <p:nvSpPr>
                    <p:cNvPr id="137" name="ZoneTexte 13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59F541E-6D76-D240-988A-58D493A519A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27149" y="7759516"/>
                      <a:ext cx="1365101" cy="523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LIMLP_02795</a:t>
                      </a:r>
                    </a:p>
                    <a:p>
                      <a:pPr algn="ctr"/>
                      <a:r>
                        <a:rPr lang="fr-FR" sz="1400" b="1" i="1" dirty="0">
                          <a:latin typeface="Arial"/>
                          <a:cs typeface="Arial"/>
                        </a:rPr>
                        <a:t>ccp</a:t>
                      </a:r>
                    </a:p>
                  </p:txBody>
                </p:sp>
                <p:grpSp>
                  <p:nvGrpSpPr>
                    <p:cNvPr id="4" name="Groupe 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4B93C38-7907-1041-933E-78FB3D6754A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831138" y="7461559"/>
                      <a:ext cx="1357122" cy="307777"/>
                      <a:chOff x="3813443" y="7461559"/>
                      <a:chExt cx="1357122" cy="307777"/>
                    </a:xfrm>
                  </p:grpSpPr>
                  <p:sp>
                    <p:nvSpPr>
                      <p:cNvPr id="178" name="ZoneTexte 177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C621C57-FEE9-1044-81FE-42A783F3BEB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813443" y="7461559"/>
                        <a:ext cx="248786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400" b="1" dirty="0">
                            <a:latin typeface="Arial"/>
                            <a:cs typeface="Arial"/>
                          </a:rPr>
                          <a:t>-</a:t>
                        </a:r>
                      </a:p>
                    </p:txBody>
                  </p:sp>
                  <p:sp>
                    <p:nvSpPr>
                      <p:cNvPr id="179" name="ZoneTexte 178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C9F5CA8-6F4A-1841-B5D0-08A68B4CF2B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881053" y="7461559"/>
                        <a:ext cx="289512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400" b="1" dirty="0">
                            <a:latin typeface="Arial"/>
                            <a:cs typeface="Arial"/>
                          </a:rPr>
                          <a:t>+</a:t>
                        </a:r>
                      </a:p>
                    </p:txBody>
                  </p:sp>
                  <p:sp>
                    <p:nvSpPr>
                      <p:cNvPr id="180" name="ZoneTexte 179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245D322-2562-7E4E-908B-D8AD7E9CC5E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35567" y="7461559"/>
                        <a:ext cx="289512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400" b="1" dirty="0">
                            <a:latin typeface="Arial"/>
                            <a:cs typeface="Arial"/>
                          </a:rPr>
                          <a:t>+</a:t>
                        </a:r>
                      </a:p>
                    </p:txBody>
                  </p:sp>
                </p:grpSp>
                <p:sp>
                  <p:nvSpPr>
                    <p:cNvPr id="33" name="Parenthèse ouvrante 3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F5ABCE8-55E6-0243-BCFD-02699BB88A4E}"/>
                        </a:ext>
                      </a:extLst>
                    </p:cNvPr>
                    <p:cNvSpPr/>
                    <p:nvPr/>
                  </p:nvSpPr>
                  <p:spPr>
                    <a:xfrm rot="16200000">
                      <a:off x="4445308" y="6830236"/>
                      <a:ext cx="128781" cy="1698339"/>
                    </a:xfrm>
                    <a:prstGeom prst="leftBracket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</p:grpSp>
            </p:grpSp>
          </p:grpSp>
          <p:grpSp>
            <p:nvGrpSpPr>
              <p:cNvPr id="17" name="Groupe 16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46EFAA3-235A-D44C-BB4E-59BC080404A9}"/>
                  </a:ext>
                </a:extLst>
              </p:cNvPr>
              <p:cNvGrpSpPr/>
              <p:nvPr/>
            </p:nvGrpSpPr>
            <p:grpSpPr>
              <a:xfrm>
                <a:off x="377014" y="537883"/>
                <a:ext cx="6366089" cy="3864680"/>
                <a:chOff x="377014" y="537883"/>
                <a:chExt cx="6366089" cy="3864680"/>
              </a:xfrm>
            </p:grpSpPr>
            <p:sp>
              <p:nvSpPr>
                <p:cNvPr id="8" name="ZoneTexte 7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A53ED36-D9AF-0B40-82F6-FF5090396BB4}"/>
                    </a:ext>
                  </a:extLst>
                </p:cNvPr>
                <p:cNvSpPr txBox="1"/>
                <p:nvPr/>
              </p:nvSpPr>
              <p:spPr>
                <a:xfrm>
                  <a:off x="377014" y="537883"/>
                  <a:ext cx="32412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b="1" dirty="0"/>
                    <a:t>A</a:t>
                  </a:r>
                </a:p>
              </p:txBody>
            </p:sp>
            <p:grpSp>
              <p:nvGrpSpPr>
                <p:cNvPr id="16" name="Groupe 1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A5E98C8-A021-CE44-A881-7EEB0F28D62B}"/>
                    </a:ext>
                  </a:extLst>
                </p:cNvPr>
                <p:cNvGrpSpPr/>
                <p:nvPr/>
              </p:nvGrpSpPr>
              <p:grpSpPr>
                <a:xfrm>
                  <a:off x="843319" y="735699"/>
                  <a:ext cx="5899784" cy="3666864"/>
                  <a:chOff x="843319" y="735699"/>
                  <a:chExt cx="5899784" cy="3666864"/>
                </a:xfrm>
              </p:grpSpPr>
              <p:sp>
                <p:nvSpPr>
                  <p:cNvPr id="188" name="ZoneTexte 18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0D50D14-C4EB-A84A-A066-32C4FC96A781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-4028" y="2015866"/>
                    <a:ext cx="2002471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fr-FR" sz="1400" b="1" dirty="0">
                        <a:latin typeface="Arial"/>
                        <a:cs typeface="Arial"/>
                      </a:rPr>
                      <a:t>Gene expression </a:t>
                    </a:r>
                    <a:r>
                      <a:rPr lang="fr-FR" sz="1400" b="1" dirty="0" err="1">
                        <a:latin typeface="Arial"/>
                        <a:cs typeface="Arial"/>
                      </a:rPr>
                      <a:t>fold</a:t>
                    </a:r>
                    <a:endParaRPr lang="fr-FR" sz="1400" b="1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91" name="ZoneTexte 190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0E51AEB-AEE1-084F-8F82-E32EF2A26E96}"/>
                      </a:ext>
                    </a:extLst>
                  </p:cNvPr>
                  <p:cNvSpPr txBox="1"/>
                  <p:nvPr/>
                </p:nvSpPr>
                <p:spPr>
                  <a:xfrm>
                    <a:off x="5388246" y="3590095"/>
                    <a:ext cx="135485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400" b="1" dirty="0">
                        <a:latin typeface="Arial"/>
                        <a:cs typeface="Arial"/>
                      </a:rPr>
                      <a:t>10 </a:t>
                    </a:r>
                    <a:r>
                      <a:rPr lang="fr-FR" sz="1400" b="1" dirty="0" err="1">
                        <a:latin typeface="Arial"/>
                        <a:cs typeface="Arial"/>
                      </a:rPr>
                      <a:t>μM</a:t>
                    </a:r>
                    <a:r>
                      <a:rPr lang="fr-FR" sz="1400" b="1" dirty="0">
                        <a:latin typeface="Arial"/>
                        <a:cs typeface="Arial"/>
                      </a:rPr>
                      <a:t> H</a:t>
                    </a:r>
                    <a:r>
                      <a:rPr lang="fr-FR" sz="1400" b="1" baseline="-25000" dirty="0">
                        <a:latin typeface="Arial"/>
                        <a:cs typeface="Arial"/>
                      </a:rPr>
                      <a:t>2</a:t>
                    </a:r>
                    <a:r>
                      <a:rPr lang="fr-FR" sz="1400" b="1" dirty="0">
                        <a:latin typeface="Arial"/>
                        <a:cs typeface="Arial"/>
                      </a:rPr>
                      <a:t>O</a:t>
                    </a:r>
                    <a:r>
                      <a:rPr lang="fr-FR" sz="1400" b="1" baseline="-25000" dirty="0">
                        <a:latin typeface="Arial"/>
                        <a:cs typeface="Arial"/>
                      </a:rPr>
                      <a:t>2</a:t>
                    </a:r>
                  </a:p>
                </p:txBody>
              </p:sp>
              <p:pic>
                <p:nvPicPr>
                  <p:cNvPr id="3" name="Image 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184FB11-F720-8B46-9C87-2751174A7FB4}"/>
                      </a:ext>
                    </a:extLst>
                  </p:cNvPr>
                  <p:cNvPicPr>
                    <a:picLocks/>
                  </p:cNvPicPr>
                  <p:nvPr/>
                </p:nvPicPr>
                <p:blipFill rotWithShape="1">
                  <a:blip r:embed="rId3"/>
                  <a:srcRect l="2469" r="4804" b="6886"/>
                  <a:stretch/>
                </p:blipFill>
                <p:spPr>
                  <a:xfrm>
                    <a:off x="1310517" y="735699"/>
                    <a:ext cx="4320000" cy="2880000"/>
                  </a:xfrm>
                  <a:prstGeom prst="rect">
                    <a:avLst/>
                  </a:prstGeom>
                </p:spPr>
              </p:pic>
              <p:grpSp>
                <p:nvGrpSpPr>
                  <p:cNvPr id="14" name="Groupe 1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D1778D0-D7A5-C942-8180-989DCAD7D8E9}"/>
                      </a:ext>
                    </a:extLst>
                  </p:cNvPr>
                  <p:cNvGrpSpPr/>
                  <p:nvPr/>
                </p:nvGrpSpPr>
                <p:grpSpPr>
                  <a:xfrm>
                    <a:off x="1695459" y="3581386"/>
                    <a:ext cx="1698339" cy="821177"/>
                    <a:chOff x="1695459" y="3581386"/>
                    <a:chExt cx="1698339" cy="821177"/>
                  </a:xfrm>
                </p:grpSpPr>
                <p:sp>
                  <p:nvSpPr>
                    <p:cNvPr id="189" name="ZoneTexte 18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9B451F6-90B7-F44A-8504-CE2D05701EF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85634" y="3879343"/>
                      <a:ext cx="1317990" cy="52322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LIMLP_05955</a:t>
                      </a:r>
                    </a:p>
                    <a:p>
                      <a:pPr algn="ctr"/>
                      <a:r>
                        <a:rPr lang="fr-FR" sz="1400" b="1" i="1" dirty="0" err="1">
                          <a:latin typeface="Arial"/>
                          <a:cs typeface="Arial"/>
                        </a:rPr>
                        <a:t>ahpC</a:t>
                      </a:r>
                      <a:endParaRPr lang="fr-FR" sz="1400" b="1" i="1" dirty="0">
                        <a:latin typeface="Arial"/>
                        <a:cs typeface="Arial"/>
                      </a:endParaRPr>
                    </a:p>
                  </p:txBody>
                </p:sp>
                <p:grpSp>
                  <p:nvGrpSpPr>
                    <p:cNvPr id="12" name="Groupe 11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08D83FB-1238-1940-847F-60F8A142871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866359" y="3581386"/>
                      <a:ext cx="1356540" cy="307777"/>
                      <a:chOff x="1874281" y="3581386"/>
                      <a:chExt cx="1356540" cy="307777"/>
                    </a:xfrm>
                  </p:grpSpPr>
                  <p:sp>
                    <p:nvSpPr>
                      <p:cNvPr id="192" name="ZoneTexte 191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A88A4CE-1900-9342-9B01-0166DC89248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874281" y="3581386"/>
                        <a:ext cx="248786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400" b="1" dirty="0">
                            <a:latin typeface="Arial"/>
                            <a:cs typeface="Arial"/>
                          </a:rPr>
                          <a:t>-</a:t>
                        </a:r>
                      </a:p>
                    </p:txBody>
                  </p:sp>
                  <p:sp>
                    <p:nvSpPr>
                      <p:cNvPr id="193" name="ZoneTexte 192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4FB8058-214D-C04C-99A6-5505D52E666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396192" y="3581386"/>
                        <a:ext cx="289512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400" b="1" dirty="0">
                            <a:latin typeface="Arial"/>
                            <a:cs typeface="Arial"/>
                          </a:rPr>
                          <a:t>+</a:t>
                        </a:r>
                      </a:p>
                    </p:txBody>
                  </p:sp>
                  <p:sp>
                    <p:nvSpPr>
                      <p:cNvPr id="194" name="ZoneTexte 19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D848BF7-5065-EF4A-B085-20545C906E7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941309" y="3581386"/>
                        <a:ext cx="289512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400" b="1" dirty="0">
                            <a:latin typeface="Arial"/>
                            <a:cs typeface="Arial"/>
                          </a:rPr>
                          <a:t>+</a:t>
                        </a:r>
                      </a:p>
                    </p:txBody>
                  </p:sp>
                </p:grpSp>
                <p:sp>
                  <p:nvSpPr>
                    <p:cNvPr id="35" name="Parenthèse ouvrante 3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7F9780F-650C-5145-8530-EE72A89A114F}"/>
                        </a:ext>
                      </a:extLst>
                    </p:cNvPr>
                    <p:cNvSpPr/>
                    <p:nvPr/>
                  </p:nvSpPr>
                  <p:spPr>
                    <a:xfrm rot="16200000">
                      <a:off x="2480238" y="2963531"/>
                      <a:ext cx="128781" cy="1698339"/>
                    </a:xfrm>
                    <a:prstGeom prst="leftBracket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</p:grpSp>
              <p:grpSp>
                <p:nvGrpSpPr>
                  <p:cNvPr id="15" name="Groupe 1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6767FFD-DEF8-9F44-8DC5-717636799AFA}"/>
                      </a:ext>
                    </a:extLst>
                  </p:cNvPr>
                  <p:cNvGrpSpPr/>
                  <p:nvPr/>
                </p:nvGrpSpPr>
                <p:grpSpPr>
                  <a:xfrm>
                    <a:off x="3689906" y="3581386"/>
                    <a:ext cx="1698339" cy="821177"/>
                    <a:chOff x="3689906" y="3581386"/>
                    <a:chExt cx="1698339" cy="821177"/>
                  </a:xfrm>
                </p:grpSpPr>
                <p:sp>
                  <p:nvSpPr>
                    <p:cNvPr id="190" name="ZoneTexte 18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3A83B4E-CC2B-4540-8AFA-DB4FDABB53F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56525" y="3879343"/>
                      <a:ext cx="1365101" cy="523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LIMLP_05960</a:t>
                      </a:r>
                    </a:p>
                    <a:p>
                      <a:pPr algn="ctr"/>
                      <a:r>
                        <a:rPr lang="fr-FR" sz="1400" b="1" i="1" dirty="0" err="1">
                          <a:latin typeface="Arial"/>
                          <a:cs typeface="Arial"/>
                        </a:rPr>
                        <a:t>sufB</a:t>
                      </a:r>
                      <a:endParaRPr lang="fr-FR" sz="1400" b="1" i="1" dirty="0">
                        <a:latin typeface="Arial"/>
                        <a:cs typeface="Arial"/>
                      </a:endParaRPr>
                    </a:p>
                  </p:txBody>
                </p:sp>
                <p:grpSp>
                  <p:nvGrpSpPr>
                    <p:cNvPr id="13" name="Groupe 1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F03FFE6-DFA9-5244-BFE5-7E3C4ACED0C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860514" y="3581386"/>
                      <a:ext cx="1357122" cy="307777"/>
                      <a:chOff x="3848279" y="3581386"/>
                      <a:chExt cx="1357122" cy="307777"/>
                    </a:xfrm>
                  </p:grpSpPr>
                  <p:sp>
                    <p:nvSpPr>
                      <p:cNvPr id="195" name="ZoneTexte 19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3C46DFD-3C49-DF49-8C9E-DE93B33DB36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848279" y="3581386"/>
                        <a:ext cx="248786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400" b="1" dirty="0">
                            <a:latin typeface="Arial"/>
                            <a:cs typeface="Arial"/>
                          </a:rPr>
                          <a:t>-</a:t>
                        </a:r>
                      </a:p>
                    </p:txBody>
                  </p:sp>
                  <p:sp>
                    <p:nvSpPr>
                      <p:cNvPr id="196" name="ZoneTexte 19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8D087CF-5122-C743-BE72-C7857AD0169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915889" y="3581386"/>
                        <a:ext cx="289512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400" b="1" dirty="0">
                            <a:latin typeface="Arial"/>
                            <a:cs typeface="Arial"/>
                          </a:rPr>
                          <a:t>+</a:t>
                        </a:r>
                      </a:p>
                    </p:txBody>
                  </p:sp>
                  <p:sp>
                    <p:nvSpPr>
                      <p:cNvPr id="197" name="ZoneTexte 196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1B4F36D-A5A9-C841-96C5-98C7EA7D5BD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70403" y="3581386"/>
                        <a:ext cx="289512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400" b="1" dirty="0">
                            <a:latin typeface="Arial"/>
                            <a:cs typeface="Arial"/>
                          </a:rPr>
                          <a:t>+</a:t>
                        </a:r>
                      </a:p>
                    </p:txBody>
                  </p:sp>
                </p:grpSp>
                <p:sp>
                  <p:nvSpPr>
                    <p:cNvPr id="38" name="Parenthèse ouvrante 37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8890C63-089E-6946-9141-541718B7144D}"/>
                        </a:ext>
                      </a:extLst>
                    </p:cNvPr>
                    <p:cNvSpPr/>
                    <p:nvPr/>
                  </p:nvSpPr>
                  <p:spPr>
                    <a:xfrm rot="16200000">
                      <a:off x="4474685" y="2957923"/>
                      <a:ext cx="128781" cy="1698339"/>
                    </a:xfrm>
                    <a:prstGeom prst="leftBracket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</p:grpSp>
            </p:grpSp>
          </p:grpSp>
        </p:grpSp>
        <p:sp>
          <p:nvSpPr>
            <p:cNvPr id="48" name="ZoneTexte 47">
              <a:extLst>
                <a:ext uri="{FF2B5EF4-FFF2-40B4-BE49-F238E27FC236}">
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FFF42BF-7D99-7448-BDC1-1BFCD45D89D3}"/>
                </a:ext>
              </a:extLst>
            </p:cNvPr>
            <p:cNvSpPr txBox="1"/>
            <p:nvPr/>
          </p:nvSpPr>
          <p:spPr>
            <a:xfrm>
              <a:off x="297497" y="8464671"/>
              <a:ext cx="63209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S2 Fig. </a:t>
              </a:r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Increase of the </a:t>
              </a:r>
              <a:r>
                <a:rPr lang="en-US" sz="11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hpC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and </a:t>
              </a:r>
              <a:r>
                <a:rPr lang="en-US" sz="11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cp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expressions </a:t>
              </a:r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upon exposure to sublethal dose of H</a:t>
              </a:r>
              <a:r>
                <a:rPr lang="en-GB" sz="11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en-GB" sz="11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fr-F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37534219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a="http://schemas.openxmlformats.org/drawingml/2006/main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</TotalTime>
  <Words>53</Words>
  <Application>Microsoft Macintosh PowerPoint</Application>
  <PresentationFormat>Présentation à l'écran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Modèle de conception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nadia benaroudj</cp:lastModifiedBy>
  <cp:revision>17</cp:revision>
  <cp:lastPrinted>2020-03-17T19:09:43Z</cp:lastPrinted>
  <dcterms:created xsi:type="dcterms:W3CDTF">2020-04-03T14:42:46Z</dcterms:created>
  <dcterms:modified xsi:type="dcterms:W3CDTF">2020-04-03T14:43:07Z</dcterms:modified>
</cp:coreProperties>
</file>